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91" d="100"/>
          <a:sy n="91" d="100"/>
        </p:scale>
        <p:origin x="69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243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76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36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554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669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54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0592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450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8864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063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120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50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4">
            <a:extLst>
              <a:ext uri="{FF2B5EF4-FFF2-40B4-BE49-F238E27FC236}">
                <a16:creationId xmlns:a16="http://schemas.microsoft.com/office/drawing/2014/main" id="{FF1B628F-7DAD-4CCF-9CD4-21DAC1B6D5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410977"/>
              </p:ext>
            </p:extLst>
          </p:nvPr>
        </p:nvGraphicFramePr>
        <p:xfrm>
          <a:off x="236306" y="1289113"/>
          <a:ext cx="8712485" cy="46246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37024">
                  <a:extLst>
                    <a:ext uri="{9D8B030D-6E8A-4147-A177-3AD203B41FA5}">
                      <a16:colId xmlns:a16="http://schemas.microsoft.com/office/drawing/2014/main" val="78145707"/>
                    </a:ext>
                  </a:extLst>
                </a:gridCol>
                <a:gridCol w="1967501">
                  <a:extLst>
                    <a:ext uri="{9D8B030D-6E8A-4147-A177-3AD203B41FA5}">
                      <a16:colId xmlns:a16="http://schemas.microsoft.com/office/drawing/2014/main" val="87713428"/>
                    </a:ext>
                  </a:extLst>
                </a:gridCol>
                <a:gridCol w="2779160">
                  <a:extLst>
                    <a:ext uri="{9D8B030D-6E8A-4147-A177-3AD203B41FA5}">
                      <a16:colId xmlns:a16="http://schemas.microsoft.com/office/drawing/2014/main" val="2714377572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322642865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Prefecture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Witnessed- OHCA patients of cardiac cause </a:t>
                      </a:r>
                      <a:r>
                        <a:rPr kumimoji="1" lang="en-US" altLang="ja-JP" dirty="0">
                          <a:solidFill>
                            <a:srgbClr val="FF0000"/>
                          </a:solidFill>
                        </a:rPr>
                        <a:t>(A)</a:t>
                      </a:r>
                      <a:endParaRPr kumimoji="1" lang="ja-JP" altLang="en-US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One-month survivor in witnessed- OHCA patients of cardiac cause </a:t>
                      </a:r>
                      <a:r>
                        <a:rPr kumimoji="1" lang="en-US" altLang="ja-JP" dirty="0">
                          <a:solidFill>
                            <a:srgbClr val="FFFF00"/>
                          </a:solidFill>
                        </a:rPr>
                        <a:t>(B)</a:t>
                      </a:r>
                      <a:endParaRPr kumimoji="1" lang="ja-JP" altLang="en-US" dirty="0">
                        <a:solidFill>
                          <a:srgbClr val="FFFF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bg1"/>
                          </a:solidFill>
                        </a:rPr>
                        <a:t>Survival rate </a:t>
                      </a:r>
                      <a:r>
                        <a:rPr kumimoji="1" lang="en-US" altLang="ja-JP" dirty="0"/>
                        <a:t>(%)</a:t>
                      </a:r>
                    </a:p>
                    <a:p>
                      <a:pPr algn="ctr"/>
                      <a:r>
                        <a:rPr kumimoji="1" lang="en-US" altLang="ja-JP" dirty="0">
                          <a:solidFill>
                            <a:srgbClr val="FFFF00"/>
                          </a:solidFill>
                        </a:rPr>
                        <a:t>(B) </a:t>
                      </a:r>
                      <a:r>
                        <a:rPr kumimoji="1" lang="en-US" altLang="ja-JP" dirty="0"/>
                        <a:t>/ </a:t>
                      </a:r>
                      <a:r>
                        <a:rPr kumimoji="1" lang="en-US" altLang="ja-JP" dirty="0">
                          <a:solidFill>
                            <a:srgbClr val="FF0000"/>
                          </a:solidFill>
                        </a:rPr>
                        <a:t>(A)</a:t>
                      </a:r>
                      <a:r>
                        <a:rPr kumimoji="1" lang="en-US" altLang="ja-JP" dirty="0"/>
                        <a:t> 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93113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Fukuoka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2,9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683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22.9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8316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Saga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638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05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6.5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02968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Nagasaki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,277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52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1.9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5145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Kumamoto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,55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204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3.2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41061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Oita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94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22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3.0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70977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Miyazaki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,091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17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0.7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2296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Kagoshima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,557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8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1.9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7266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Okinawa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,300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26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20.5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1969647"/>
                  </a:ext>
                </a:extLst>
              </a:tr>
              <a:tr h="372667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All Japan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26,919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7,173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/>
                        <a:t>13.5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6902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b="1" dirty="0"/>
                        <a:t>Miyazaki city district</a:t>
                      </a:r>
                      <a:endParaRPr kumimoji="1" lang="ja-JP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/>
                        <a:t>452</a:t>
                      </a:r>
                      <a:endParaRPr kumimoji="1" lang="ja-JP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/>
                        <a:t>71</a:t>
                      </a:r>
                      <a:endParaRPr kumimoji="1" lang="ja-JP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/>
                        <a:t>15.7</a:t>
                      </a:r>
                      <a:endParaRPr kumimoji="1" lang="ja-JP" altLang="en-US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0542347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9F93659-E01E-4C7D-B788-6364117F01A0}"/>
              </a:ext>
            </a:extLst>
          </p:cNvPr>
          <p:cNvSpPr txBox="1"/>
          <p:nvPr/>
        </p:nvSpPr>
        <p:spPr>
          <a:xfrm>
            <a:off x="61651" y="51377"/>
            <a:ext cx="1078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2 Tabl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EAB93B1-71A2-401A-A0EF-733CFFD939F9}"/>
              </a:ext>
            </a:extLst>
          </p:cNvPr>
          <p:cNvSpPr txBox="1"/>
          <p:nvPr/>
        </p:nvSpPr>
        <p:spPr>
          <a:xfrm>
            <a:off x="41096" y="579956"/>
            <a:ext cx="90823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ne-month survival rate in OHCA patients of cardiac cause </a:t>
            </a:r>
          </a:p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in Miyazaki city district, and Kyushu-Okinawa region between 2015 and 2019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EB511C9-13BD-4DEA-BE24-5E72E817591B}"/>
              </a:ext>
            </a:extLst>
          </p:cNvPr>
          <p:cNvSpPr txBox="1"/>
          <p:nvPr/>
        </p:nvSpPr>
        <p:spPr>
          <a:xfrm>
            <a:off x="5840862" y="6124155"/>
            <a:ext cx="30700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HCA, out-of-hospital cardiac arrest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4751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</TotalTime>
  <Words>103</Words>
  <Application>Microsoft Office PowerPoint</Application>
  <PresentationFormat>画面に合わせる (4:3)</PresentationFormat>
  <Paragraphs>4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鶴田 敏博</dc:creator>
  <cp:lastModifiedBy>鶴田 敏博</cp:lastModifiedBy>
  <cp:revision>36</cp:revision>
  <dcterms:created xsi:type="dcterms:W3CDTF">2021-09-15T03:45:20Z</dcterms:created>
  <dcterms:modified xsi:type="dcterms:W3CDTF">2022-08-14T02:12:15Z</dcterms:modified>
</cp:coreProperties>
</file>